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91" d="100"/>
          <a:sy n="91" d="100"/>
        </p:scale>
        <p:origin x="672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979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6960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3516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7768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7324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363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6051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1573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1086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4155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7744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CD4242-AE2E-47FB-A294-B18A83F67773}" type="datetimeFigureOut">
              <a:rPr lang="de-DE" smtClean="0"/>
              <a:t>19.03.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A8752D-7A0F-40F7-8FC2-7B002F5F1C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1940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90102" y="240574"/>
            <a:ext cx="4288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F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(to reviewer only)</a:t>
            </a:r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/>
          <a:srcRect r="24600" b="19231"/>
          <a:stretch/>
        </p:blipFill>
        <p:spPr>
          <a:xfrm>
            <a:off x="957827" y="808425"/>
            <a:ext cx="3698579" cy="576321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79F8EF9-5E36-B8CA-E1F9-9F81FDC6DC41}"/>
              </a:ext>
            </a:extLst>
          </p:cNvPr>
          <p:cNvSpPr txBox="1"/>
          <p:nvPr/>
        </p:nvSpPr>
        <p:spPr>
          <a:xfrm>
            <a:off x="6096000" y="4755758"/>
            <a:ext cx="552186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. Figure 2. </a:t>
            </a:r>
            <a:r>
              <a:rPr lang="en-US" sz="16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SEA-4 expression levels during 28-day </a:t>
            </a:r>
            <a:r>
              <a:rPr lang="en-US" sz="1600" i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n vitro</a:t>
            </a:r>
            <a:r>
              <a:rPr lang="en-US" sz="16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ulture of sorted SSEA-4</a:t>
            </a:r>
            <a:r>
              <a:rPr lang="en-US" sz="1600" baseline="300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ow</a:t>
            </a:r>
            <a:r>
              <a:rPr lang="en-US" sz="16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SSEA-4</a:t>
            </a:r>
            <a:r>
              <a:rPr lang="en-US" sz="1600" baseline="300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high</a:t>
            </a:r>
            <a:r>
              <a:rPr lang="en-US" sz="16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ubpopulations from four EwS cell lines analyzed by flow cytometry. Shown is the SSEA-4 expression density quantified by median RFI of the parental cell lines, directly after sorting and on cells from SSEA-4</a:t>
            </a:r>
            <a:r>
              <a:rPr lang="en-US" sz="1600" baseline="300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low</a:t>
            </a:r>
            <a:r>
              <a:rPr lang="en-US" sz="16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SSEA-4</a:t>
            </a:r>
            <a:r>
              <a:rPr lang="en-US" sz="1600" baseline="300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high</a:t>
            </a:r>
            <a:r>
              <a:rPr lang="en-US" sz="160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ubpopulations after 7 days of continued cell culture. </a:t>
            </a:r>
            <a:endParaRPr lang="en-DE" sz="16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210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71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SEA-4</dc:title>
  <dc:creator>Altvater, Bianca</dc:creator>
  <cp:lastModifiedBy>rossig@uni-muenster.de</cp:lastModifiedBy>
  <cp:revision>13</cp:revision>
  <dcterms:created xsi:type="dcterms:W3CDTF">2024-03-18T06:49:54Z</dcterms:created>
  <dcterms:modified xsi:type="dcterms:W3CDTF">2024-03-19T05:08:50Z</dcterms:modified>
</cp:coreProperties>
</file>